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8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7237" autoAdjust="0"/>
  </p:normalViewPr>
  <p:slideViewPr>
    <p:cSldViewPr snapToGrid="0">
      <p:cViewPr varScale="1">
        <p:scale>
          <a:sx n="82" d="100"/>
          <a:sy n="82" d="100"/>
        </p:scale>
        <p:origin x="267" y="3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141EFE-6009-4924-973E-EC40E7F589ED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9C6E1C-CAAA-46CF-B489-D42534EB93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33797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>
              <a:lnSpc>
                <a:spcPct val="150000"/>
              </a:lnSpc>
            </a:pPr>
            <a:r>
              <a:rPr lang="en-US" altLang="zh-CN" sz="1800" b="1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Figure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1.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hange of dynamic compliance plotted against 24-hour fluid balance, showing numbers of patients in each quadrant with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p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= 0.004 by Pearson's chi-squared test. A Spearman’s rank correlation test showed weak correlation between them. (r = -0.113,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p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= 0.006)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F9C6E1C-CAAA-46CF-B489-D42534EB93FC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7160110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>
              <a:lnSpc>
                <a:spcPct val="150000"/>
              </a:lnSpc>
            </a:pPr>
            <a:r>
              <a:rPr lang="en-US" altLang="zh-CN" sz="1800" b="1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Figure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2.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echanical power calculated by our surrogate equation (area in solid blue line) compared with the reference methods (area in solid red line) in both pressure-controlled and volume-controlled modes. VT = tidal volume; PEEP = positive end-expiratory pressure;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plat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= plateau pressure;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peak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= peak inspiratory </a:t>
            </a:r>
            <a:r>
              <a:rPr lang="en-US" altLang="zh-CN" sz="1800" kern="10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ressure.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F9C6E1C-CAAA-46CF-B489-D42534EB93FC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48184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FB55229-967E-4A18-9068-426AA056F2E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07EE1AB-5A50-471C-997F-D4D2D4CFAD4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F0E2FBA-92EC-4EDF-BADF-999951D972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19A56-5278-4063-8023-8486EC371A3C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8EDF0DD-6FBC-4F2B-9FCA-0E46714180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C38EC47-3843-4636-A497-0E1FAEF8CB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8C431-10FC-481D-855B-9522743C6C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20676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5C4EE70-6186-4B88-AA8A-B348B97264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A1FBF73-0E63-4FB9-B4CC-E42BDEF01E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CCCCAC9-561B-4926-99E8-0F9F75AE72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19A56-5278-4063-8023-8486EC371A3C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FFD088B-7D90-41BC-9897-9EC3BEEF27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686CFEF-8085-45F9-9238-ACDEA9DD31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8C431-10FC-481D-855B-9522743C6C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71937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C90AAF1-4221-430F-ABFF-F33DA940B60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F387DC9-75B7-4AB3-806C-5746D715C77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312E444-D2E2-4DB2-8D5E-DD6A79ADC8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19A56-5278-4063-8023-8486EC371A3C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7CC84E2-6DCB-4952-9D19-4DF0CE058C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3C4A0FA-9CEF-443E-9EDB-E768CA7515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8C431-10FC-481D-855B-9522743C6C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20942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2FF7C3D-B520-4F3A-A3EA-5DD99CB82A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9118FD4-0E55-4714-BEDE-E477D088BAA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301C9B2-4AE5-403F-AFD8-8AEEA66954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19A56-5278-4063-8023-8486EC371A3C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959AE39-86B6-4DD8-BBA6-27C4402272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35C1CCA-90CC-4E5C-9840-9A863E261F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8C431-10FC-481D-855B-9522743C6C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78266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6D35097-993D-4A77-86C7-CF22736B70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8365C30-C696-4984-B086-5A1054FBC3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719F95F-9949-44C7-8FCA-EE2C96D404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19A56-5278-4063-8023-8486EC371A3C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01989D3-BEC1-4E98-ABAA-DACC73362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A0172BE-BBDB-4A67-9074-AC215273FC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8C431-10FC-481D-855B-9522743C6C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45777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403D2D0-37D0-491D-900C-B6C7B3C83A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34D3B77-8E29-44FC-BF04-F73945B665B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D6AAC76-A53D-4741-8C9C-8EA099A83C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485F909-A0E6-472D-B41D-96045D199E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19A56-5278-4063-8023-8486EC371A3C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C5792A3-FC85-4B50-BC97-2EDEEB61F9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D84034A-B34F-4C61-ABC2-BCF5C89F75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8C431-10FC-481D-855B-9522743C6C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34209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EA07BE2-66B8-48D2-A187-8F4FAB12C4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3CF9E38-6C46-4624-AD72-F488E233E2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1D6245C-1A8E-4B42-AA6F-EBA717DECD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DBBAAB8-574A-417C-B694-E51759B08F5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5D00561-C108-4656-87E9-A3E22551E95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0A27CEA-99D6-4BE6-922D-2C2895DCEE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19A56-5278-4063-8023-8486EC371A3C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AB3D99E-CCDC-4780-903D-5117E0833F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21BD3012-4411-4FE2-BC26-F6B77232C1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8C431-10FC-481D-855B-9522743C6C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74147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A1E2F6B-8FC3-4435-B0F3-830B6C1525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68EDFF21-A25A-4E3A-A4FB-DC37D033CC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19A56-5278-4063-8023-8486EC371A3C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428852E-9EDB-4DB5-863A-0C96709FB2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AF9B7226-BCC2-41F0-BE73-5CF6E17ED8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8C431-10FC-481D-855B-9522743C6C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14566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5F35BB4-F621-425E-A010-1ED06E3A2D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19A56-5278-4063-8023-8486EC371A3C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F38D0BD7-90B1-4CAF-B60E-92CE0F7874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A1723ED-BE02-4FE5-BA85-E046BAE4A8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8C431-10FC-481D-855B-9522743C6C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83646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67406E1-0075-4C40-B039-D7C49B15B2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9B88A1E-3EF7-47F4-8F55-0834E797012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F82295C-F960-4265-812A-BE3DE5D6DE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264D598-8DDC-43A9-AA7B-E0FA3DAB6C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19A56-5278-4063-8023-8486EC371A3C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8B092E2-3D28-4DDA-AF67-E3FFB71046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61616EC-470E-4711-A81B-94031DE85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8C431-10FC-481D-855B-9522743C6C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40257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B8893CA-DDDC-40BF-B466-259DCF95A6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DFB3F05-DFC0-4A0F-82FE-ECDBB43B72F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BB1DA3A-9A41-418C-BCE6-5497FA26F3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9B98717-6AB6-4155-A025-38B3EF787C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19A56-5278-4063-8023-8486EC371A3C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FB49E0E-BDD5-4D1F-9634-97E487D2EA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D063D83-CD82-4C99-A8E6-B4B6A52FE4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8C431-10FC-481D-855B-9522743C6C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40677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5B5874A-5B43-49DA-86EE-3CFCA3169A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45A0566-A4CD-4218-852B-C31D57B2A9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188F138-80AE-4D86-BC0A-40CB04D8036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519A56-5278-4063-8023-8486EC371A3C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B656E13-9854-459F-B378-5FEB36F953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83AAE8B-C2D6-425C-9819-2A38C4CD944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78C431-10FC-481D-855B-9522743C6C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503270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752DDD5B-EC77-402C-A452-D6E7ACEB004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7699" y="53149"/>
            <a:ext cx="9312902" cy="67927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33020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7" name="组合 146">
            <a:extLst>
              <a:ext uri="{FF2B5EF4-FFF2-40B4-BE49-F238E27FC236}">
                <a16:creationId xmlns:a16="http://schemas.microsoft.com/office/drawing/2014/main" id="{C3909C52-C765-4B94-9DBB-AD2959D4DC82}"/>
              </a:ext>
            </a:extLst>
          </p:cNvPr>
          <p:cNvGrpSpPr/>
          <p:nvPr/>
        </p:nvGrpSpPr>
        <p:grpSpPr>
          <a:xfrm>
            <a:off x="1302069" y="1231493"/>
            <a:ext cx="9752467" cy="4579680"/>
            <a:chOff x="1302069" y="1231493"/>
            <a:chExt cx="9752467" cy="4579680"/>
          </a:xfrm>
        </p:grpSpPr>
        <p:cxnSp>
          <p:nvCxnSpPr>
            <p:cNvPr id="3" name="直接箭头连接符 2">
              <a:extLst>
                <a:ext uri="{FF2B5EF4-FFF2-40B4-BE49-F238E27FC236}">
                  <a16:creationId xmlns:a16="http://schemas.microsoft.com/office/drawing/2014/main" id="{464145C5-795D-4DD7-8671-C23941D566B7}"/>
                </a:ext>
              </a:extLst>
            </p:cNvPr>
            <p:cNvCxnSpPr/>
            <p:nvPr/>
          </p:nvCxnSpPr>
          <p:spPr>
            <a:xfrm>
              <a:off x="2140901" y="4407737"/>
              <a:ext cx="3843765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直接箭头连接符 4">
              <a:extLst>
                <a:ext uri="{FF2B5EF4-FFF2-40B4-BE49-F238E27FC236}">
                  <a16:creationId xmlns:a16="http://schemas.microsoft.com/office/drawing/2014/main" id="{EA4838D5-5DAB-44B9-AFB7-88BFDD6E36C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40901" y="1610695"/>
              <a:ext cx="0" cy="2797042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接连接符 8">
              <a:extLst>
                <a:ext uri="{FF2B5EF4-FFF2-40B4-BE49-F238E27FC236}">
                  <a16:creationId xmlns:a16="http://schemas.microsoft.com/office/drawing/2014/main" id="{AB3B6EE3-EF22-4F6F-A56E-6CB7466AB49C}"/>
                </a:ext>
              </a:extLst>
            </p:cNvPr>
            <p:cNvCxnSpPr>
              <a:cxnSpLocks/>
              <a:endCxn id="11" idx="0"/>
            </p:cNvCxnSpPr>
            <p:nvPr/>
          </p:nvCxnSpPr>
          <p:spPr>
            <a:xfrm>
              <a:off x="2140901" y="2573461"/>
              <a:ext cx="1872603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任意多边形: 形状 10">
              <a:extLst>
                <a:ext uri="{FF2B5EF4-FFF2-40B4-BE49-F238E27FC236}">
                  <a16:creationId xmlns:a16="http://schemas.microsoft.com/office/drawing/2014/main" id="{D616D8B7-1CED-4E23-AC49-B05C99A7081B}"/>
                </a:ext>
              </a:extLst>
            </p:cNvPr>
            <p:cNvSpPr/>
            <p:nvPr/>
          </p:nvSpPr>
          <p:spPr>
            <a:xfrm>
              <a:off x="2140901" y="2573461"/>
              <a:ext cx="1872603" cy="1831319"/>
            </a:xfrm>
            <a:custGeom>
              <a:avLst/>
              <a:gdLst>
                <a:gd name="connsiteX0" fmla="*/ 1872603 w 1872603"/>
                <a:gd name="connsiteY0" fmla="*/ 0 h 1831319"/>
                <a:gd name="connsiteX1" fmla="*/ 1801422 w 1872603"/>
                <a:gd name="connsiteY1" fmla="*/ 459938 h 1831319"/>
                <a:gd name="connsiteX2" fmla="*/ 1680962 w 1872603"/>
                <a:gd name="connsiteY2" fmla="*/ 969155 h 1831319"/>
                <a:gd name="connsiteX3" fmla="*/ 1286730 w 1872603"/>
                <a:gd name="connsiteY3" fmla="*/ 1472896 h 1831319"/>
                <a:gd name="connsiteX4" fmla="*/ 897973 w 1872603"/>
                <a:gd name="connsiteY4" fmla="*/ 1724767 h 1831319"/>
                <a:gd name="connsiteX5" fmla="*/ 492790 w 1872603"/>
                <a:gd name="connsiteY5" fmla="*/ 1817849 h 1831319"/>
                <a:gd name="connsiteX6" fmla="*/ 0 w 1872603"/>
                <a:gd name="connsiteY6" fmla="*/ 1828800 h 183131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872603" h="1831319">
                  <a:moveTo>
                    <a:pt x="1872603" y="0"/>
                  </a:moveTo>
                  <a:cubicBezTo>
                    <a:pt x="1852982" y="149206"/>
                    <a:pt x="1833362" y="298412"/>
                    <a:pt x="1801422" y="459938"/>
                  </a:cubicBezTo>
                  <a:cubicBezTo>
                    <a:pt x="1769482" y="621464"/>
                    <a:pt x="1766744" y="800329"/>
                    <a:pt x="1680962" y="969155"/>
                  </a:cubicBezTo>
                  <a:cubicBezTo>
                    <a:pt x="1595180" y="1137981"/>
                    <a:pt x="1417228" y="1346961"/>
                    <a:pt x="1286730" y="1472896"/>
                  </a:cubicBezTo>
                  <a:cubicBezTo>
                    <a:pt x="1156232" y="1598831"/>
                    <a:pt x="1030296" y="1667275"/>
                    <a:pt x="897973" y="1724767"/>
                  </a:cubicBezTo>
                  <a:cubicBezTo>
                    <a:pt x="765650" y="1782259"/>
                    <a:pt x="642452" y="1800510"/>
                    <a:pt x="492790" y="1817849"/>
                  </a:cubicBezTo>
                  <a:cubicBezTo>
                    <a:pt x="343128" y="1835188"/>
                    <a:pt x="171564" y="1831994"/>
                    <a:pt x="0" y="1828800"/>
                  </a:cubicBezTo>
                </a:path>
              </a:pathLst>
            </a:cu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6" name="直接连接符 15">
              <a:extLst>
                <a:ext uri="{FF2B5EF4-FFF2-40B4-BE49-F238E27FC236}">
                  <a16:creationId xmlns:a16="http://schemas.microsoft.com/office/drawing/2014/main" id="{2E6DB653-E870-45A5-B414-20A9CF0B8D99}"/>
                </a:ext>
              </a:extLst>
            </p:cNvPr>
            <p:cNvCxnSpPr>
              <a:cxnSpLocks/>
            </p:cNvCxnSpPr>
            <p:nvPr/>
          </p:nvCxnSpPr>
          <p:spPr>
            <a:xfrm>
              <a:off x="2140901" y="2606313"/>
              <a:ext cx="2628215" cy="0"/>
            </a:xfrm>
            <a:prstGeom prst="line">
              <a:avLst/>
            </a:prstGeom>
            <a:ln w="3810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接连接符 17">
              <a:extLst>
                <a:ext uri="{FF2B5EF4-FFF2-40B4-BE49-F238E27FC236}">
                  <a16:creationId xmlns:a16="http://schemas.microsoft.com/office/drawing/2014/main" id="{F48A0407-7C9F-4106-9357-9A473A828D91}"/>
                </a:ext>
              </a:extLst>
            </p:cNvPr>
            <p:cNvCxnSpPr>
              <a:cxnSpLocks/>
              <a:stCxn id="11" idx="6"/>
            </p:cNvCxnSpPr>
            <p:nvPr/>
          </p:nvCxnSpPr>
          <p:spPr>
            <a:xfrm flipV="1">
              <a:off x="2140901" y="2617266"/>
              <a:ext cx="2628215" cy="1784995"/>
            </a:xfrm>
            <a:prstGeom prst="line">
              <a:avLst/>
            </a:prstGeom>
            <a:ln w="3810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接连接符 21">
              <a:extLst>
                <a:ext uri="{FF2B5EF4-FFF2-40B4-BE49-F238E27FC236}">
                  <a16:creationId xmlns:a16="http://schemas.microsoft.com/office/drawing/2014/main" id="{59540AA2-9AA7-4896-A686-F4845343F9EF}"/>
                </a:ext>
              </a:extLst>
            </p:cNvPr>
            <p:cNvCxnSpPr>
              <a:cxnSpLocks/>
              <a:endCxn id="11" idx="6"/>
            </p:cNvCxnSpPr>
            <p:nvPr/>
          </p:nvCxnSpPr>
          <p:spPr>
            <a:xfrm>
              <a:off x="2140901" y="2573461"/>
              <a:ext cx="0" cy="182880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接连接符 24">
              <a:extLst>
                <a:ext uri="{FF2B5EF4-FFF2-40B4-BE49-F238E27FC236}">
                  <a16:creationId xmlns:a16="http://schemas.microsoft.com/office/drawing/2014/main" id="{DC22F577-3204-4D41-908B-ECB279FD4A0B}"/>
                </a:ext>
              </a:extLst>
            </p:cNvPr>
            <p:cNvCxnSpPr>
              <a:cxnSpLocks/>
            </p:cNvCxnSpPr>
            <p:nvPr/>
          </p:nvCxnSpPr>
          <p:spPr>
            <a:xfrm>
              <a:off x="2178318" y="2573461"/>
              <a:ext cx="0" cy="1828800"/>
            </a:xfrm>
            <a:prstGeom prst="line">
              <a:avLst/>
            </a:prstGeom>
            <a:ln w="3810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接连接符 45">
              <a:extLst>
                <a:ext uri="{FF2B5EF4-FFF2-40B4-BE49-F238E27FC236}">
                  <a16:creationId xmlns:a16="http://schemas.microsoft.com/office/drawing/2014/main" id="{B7B10031-6750-4A34-A152-B88A7DAE7125}"/>
                </a:ext>
              </a:extLst>
            </p:cNvPr>
            <p:cNvCxnSpPr>
              <a:cxnSpLocks/>
              <a:stCxn id="11" idx="0"/>
            </p:cNvCxnSpPr>
            <p:nvPr/>
          </p:nvCxnSpPr>
          <p:spPr>
            <a:xfrm flipH="1">
              <a:off x="3987836" y="2573461"/>
              <a:ext cx="25668" cy="1828800"/>
            </a:xfrm>
            <a:prstGeom prst="line">
              <a:avLst/>
            </a:prstGeom>
            <a:ln w="38100">
              <a:prstDash val="sys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BEA7F170-7CBA-4F99-97CE-FAA32E0C9F3D}"/>
                </a:ext>
              </a:extLst>
            </p:cNvPr>
            <p:cNvSpPr txBox="1"/>
            <p:nvPr/>
          </p:nvSpPr>
          <p:spPr>
            <a:xfrm>
              <a:off x="3465908" y="5441841"/>
              <a:ext cx="10695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essure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文本框 74">
              <a:extLst>
                <a:ext uri="{FF2B5EF4-FFF2-40B4-BE49-F238E27FC236}">
                  <a16:creationId xmlns:a16="http://schemas.microsoft.com/office/drawing/2014/main" id="{F640B39E-C729-4CF1-90C2-29C4D0AF8A64}"/>
                </a:ext>
              </a:extLst>
            </p:cNvPr>
            <p:cNvSpPr txBox="1"/>
            <p:nvPr/>
          </p:nvSpPr>
          <p:spPr>
            <a:xfrm rot="16200000">
              <a:off x="1020261" y="2885088"/>
              <a:ext cx="93294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olume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7E46B088-2376-497B-9B31-90332BE46DE4}"/>
                </a:ext>
              </a:extLst>
            </p:cNvPr>
            <p:cNvSpPr txBox="1"/>
            <p:nvPr/>
          </p:nvSpPr>
          <p:spPr>
            <a:xfrm>
              <a:off x="1681213" y="2416171"/>
              <a:ext cx="5052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T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id="{EBED8294-D59A-45C5-B748-393030706BCB}"/>
                </a:ext>
              </a:extLst>
            </p:cNvPr>
            <p:cNvSpPr txBox="1"/>
            <p:nvPr/>
          </p:nvSpPr>
          <p:spPr>
            <a:xfrm>
              <a:off x="3575703" y="4427432"/>
              <a:ext cx="82426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peak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左大括号 79">
              <a:extLst>
                <a:ext uri="{FF2B5EF4-FFF2-40B4-BE49-F238E27FC236}">
                  <a16:creationId xmlns:a16="http://schemas.microsoft.com/office/drawing/2014/main" id="{7126E66D-7EBC-4094-B822-79E08B569AB6}"/>
                </a:ext>
              </a:extLst>
            </p:cNvPr>
            <p:cNvSpPr/>
            <p:nvPr/>
          </p:nvSpPr>
          <p:spPr>
            <a:xfrm rot="5400000">
              <a:off x="4322707" y="2056656"/>
              <a:ext cx="143597" cy="706321"/>
            </a:xfrm>
            <a:prstGeom prst="leftBrac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文本框 81">
              <a:extLst>
                <a:ext uri="{FF2B5EF4-FFF2-40B4-BE49-F238E27FC236}">
                  <a16:creationId xmlns:a16="http://schemas.microsoft.com/office/drawing/2014/main" id="{FA3350BB-1154-476E-B042-B472CC534AA0}"/>
                </a:ext>
              </a:extLst>
            </p:cNvPr>
            <p:cNvSpPr txBox="1"/>
            <p:nvPr/>
          </p:nvSpPr>
          <p:spPr>
            <a:xfrm>
              <a:off x="3277212" y="1856182"/>
              <a:ext cx="22345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alue equal to PEEP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3" name="直接箭头连接符 82">
              <a:extLst>
                <a:ext uri="{FF2B5EF4-FFF2-40B4-BE49-F238E27FC236}">
                  <a16:creationId xmlns:a16="http://schemas.microsoft.com/office/drawing/2014/main" id="{02F4888B-70DC-4666-AF01-1B84381C3ABF}"/>
                </a:ext>
              </a:extLst>
            </p:cNvPr>
            <p:cNvCxnSpPr/>
            <p:nvPr/>
          </p:nvCxnSpPr>
          <p:spPr>
            <a:xfrm>
              <a:off x="7210771" y="4402261"/>
              <a:ext cx="3843765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直接箭头连接符 83">
              <a:extLst>
                <a:ext uri="{FF2B5EF4-FFF2-40B4-BE49-F238E27FC236}">
                  <a16:creationId xmlns:a16="http://schemas.microsoft.com/office/drawing/2014/main" id="{CCC6F2E1-97BC-4193-9342-EBC0F6E3B74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210771" y="1605219"/>
              <a:ext cx="0" cy="2797042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直接连接符 84">
              <a:extLst>
                <a:ext uri="{FF2B5EF4-FFF2-40B4-BE49-F238E27FC236}">
                  <a16:creationId xmlns:a16="http://schemas.microsoft.com/office/drawing/2014/main" id="{A2502F42-41F5-4CB2-BECF-DAEE52EE1A1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246319" y="2589885"/>
              <a:ext cx="3118706" cy="4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直接连接符 87">
              <a:extLst>
                <a:ext uri="{FF2B5EF4-FFF2-40B4-BE49-F238E27FC236}">
                  <a16:creationId xmlns:a16="http://schemas.microsoft.com/office/drawing/2014/main" id="{343ACAE8-8CA7-446A-B942-550D883BC58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908979" y="2619786"/>
              <a:ext cx="2435274" cy="1747524"/>
            </a:xfrm>
            <a:prstGeom prst="line">
              <a:avLst/>
            </a:prstGeom>
            <a:ln w="3810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直接连接符 88">
              <a:extLst>
                <a:ext uri="{FF2B5EF4-FFF2-40B4-BE49-F238E27FC236}">
                  <a16:creationId xmlns:a16="http://schemas.microsoft.com/office/drawing/2014/main" id="{0E9978DA-9706-4B34-928C-9A3B985A90FB}"/>
                </a:ext>
              </a:extLst>
            </p:cNvPr>
            <p:cNvCxnSpPr>
              <a:cxnSpLocks/>
            </p:cNvCxnSpPr>
            <p:nvPr/>
          </p:nvCxnSpPr>
          <p:spPr>
            <a:xfrm>
              <a:off x="7246319" y="2589889"/>
              <a:ext cx="0" cy="182880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直接连接符 89">
              <a:extLst>
                <a:ext uri="{FF2B5EF4-FFF2-40B4-BE49-F238E27FC236}">
                  <a16:creationId xmlns:a16="http://schemas.microsoft.com/office/drawing/2014/main" id="{66D81E4F-28C0-4124-9D36-E2E29E8E5CED}"/>
                </a:ext>
              </a:extLst>
            </p:cNvPr>
            <p:cNvCxnSpPr>
              <a:cxnSpLocks/>
              <a:stCxn id="109" idx="3"/>
            </p:cNvCxnSpPr>
            <p:nvPr/>
          </p:nvCxnSpPr>
          <p:spPr>
            <a:xfrm flipH="1">
              <a:off x="7248188" y="2595361"/>
              <a:ext cx="8162" cy="1801424"/>
            </a:xfrm>
            <a:prstGeom prst="line">
              <a:avLst/>
            </a:prstGeom>
            <a:ln w="3810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7" name="文本框 106">
              <a:extLst>
                <a:ext uri="{FF2B5EF4-FFF2-40B4-BE49-F238E27FC236}">
                  <a16:creationId xmlns:a16="http://schemas.microsoft.com/office/drawing/2014/main" id="{3ED56187-DF20-49FA-AB86-C61A8E8A5B94}"/>
                </a:ext>
              </a:extLst>
            </p:cNvPr>
            <p:cNvSpPr txBox="1"/>
            <p:nvPr/>
          </p:nvSpPr>
          <p:spPr>
            <a:xfrm>
              <a:off x="8545270" y="5441841"/>
              <a:ext cx="10695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essure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" name="文本框 107">
              <a:extLst>
                <a:ext uri="{FF2B5EF4-FFF2-40B4-BE49-F238E27FC236}">
                  <a16:creationId xmlns:a16="http://schemas.microsoft.com/office/drawing/2014/main" id="{6E36FFE1-E82B-4E47-92AD-088270325CF5}"/>
                </a:ext>
              </a:extLst>
            </p:cNvPr>
            <p:cNvSpPr txBox="1"/>
            <p:nvPr/>
          </p:nvSpPr>
          <p:spPr>
            <a:xfrm rot="16200000">
              <a:off x="6090131" y="2879612"/>
              <a:ext cx="93294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olume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" name="文本框 108">
              <a:extLst>
                <a:ext uri="{FF2B5EF4-FFF2-40B4-BE49-F238E27FC236}">
                  <a16:creationId xmlns:a16="http://schemas.microsoft.com/office/drawing/2014/main" id="{19FDD0F1-5942-4000-81C6-1E74C02FD085}"/>
                </a:ext>
              </a:extLst>
            </p:cNvPr>
            <p:cNvSpPr txBox="1"/>
            <p:nvPr/>
          </p:nvSpPr>
          <p:spPr>
            <a:xfrm>
              <a:off x="6751083" y="2410695"/>
              <a:ext cx="5052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T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" name="文本框 109">
              <a:extLst>
                <a:ext uri="{FF2B5EF4-FFF2-40B4-BE49-F238E27FC236}">
                  <a16:creationId xmlns:a16="http://schemas.microsoft.com/office/drawing/2014/main" id="{E34982CD-0510-40AE-B6C4-EC6C4E397E97}"/>
                </a:ext>
              </a:extLst>
            </p:cNvPr>
            <p:cNvSpPr txBox="1"/>
            <p:nvPr/>
          </p:nvSpPr>
          <p:spPr>
            <a:xfrm>
              <a:off x="9914391" y="4376476"/>
              <a:ext cx="82426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peak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15" name="直接连接符 114">
              <a:extLst>
                <a:ext uri="{FF2B5EF4-FFF2-40B4-BE49-F238E27FC236}">
                  <a16:creationId xmlns:a16="http://schemas.microsoft.com/office/drawing/2014/main" id="{F3159E80-DDC9-4D3E-9A8D-EB7999226B8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634004" y="2605958"/>
              <a:ext cx="1731021" cy="1775904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直接连接符 117">
              <a:extLst>
                <a:ext uri="{FF2B5EF4-FFF2-40B4-BE49-F238E27FC236}">
                  <a16:creationId xmlns:a16="http://schemas.microsoft.com/office/drawing/2014/main" id="{AA7FE373-F151-4D0D-B792-6A7A03545F0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277318" y="4367310"/>
              <a:ext cx="1374201" cy="9166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直接连接符 129">
              <a:extLst>
                <a:ext uri="{FF2B5EF4-FFF2-40B4-BE49-F238E27FC236}">
                  <a16:creationId xmlns:a16="http://schemas.microsoft.com/office/drawing/2014/main" id="{0BB728F7-69FD-4C16-A3F8-D2DCA6834061}"/>
                </a:ext>
              </a:extLst>
            </p:cNvPr>
            <p:cNvCxnSpPr>
              <a:cxnSpLocks/>
            </p:cNvCxnSpPr>
            <p:nvPr/>
          </p:nvCxnSpPr>
          <p:spPr>
            <a:xfrm>
              <a:off x="7277318" y="4359023"/>
              <a:ext cx="639757" cy="0"/>
            </a:xfrm>
            <a:prstGeom prst="line">
              <a:avLst/>
            </a:prstGeom>
            <a:ln w="3810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直接连接符 133">
              <a:extLst>
                <a:ext uri="{FF2B5EF4-FFF2-40B4-BE49-F238E27FC236}">
                  <a16:creationId xmlns:a16="http://schemas.microsoft.com/office/drawing/2014/main" id="{1C499324-5F78-45D8-AC08-4BCB637CD35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246670" y="2611275"/>
              <a:ext cx="3087904" cy="5476"/>
            </a:xfrm>
            <a:prstGeom prst="line">
              <a:avLst/>
            </a:prstGeom>
            <a:ln w="3810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直接连接符 138">
              <a:extLst>
                <a:ext uri="{FF2B5EF4-FFF2-40B4-BE49-F238E27FC236}">
                  <a16:creationId xmlns:a16="http://schemas.microsoft.com/office/drawing/2014/main" id="{EA159A90-2692-4E97-9CE3-22360AE2E6B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326524" y="2592368"/>
              <a:ext cx="25668" cy="1828800"/>
            </a:xfrm>
            <a:prstGeom prst="line">
              <a:avLst/>
            </a:prstGeom>
            <a:ln w="38100">
              <a:prstDash val="sys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1" name="直接连接符 140">
              <a:extLst>
                <a:ext uri="{FF2B5EF4-FFF2-40B4-BE49-F238E27FC236}">
                  <a16:creationId xmlns:a16="http://schemas.microsoft.com/office/drawing/2014/main" id="{9C3F7DBA-2810-46E3-B0CC-1191D65AF18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625147" y="2604107"/>
              <a:ext cx="25668" cy="1828800"/>
            </a:xfrm>
            <a:prstGeom prst="line">
              <a:avLst/>
            </a:prstGeom>
            <a:ln w="38100">
              <a:prstDash val="sys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2" name="文本框 141">
              <a:extLst>
                <a:ext uri="{FF2B5EF4-FFF2-40B4-BE49-F238E27FC236}">
                  <a16:creationId xmlns:a16="http://schemas.microsoft.com/office/drawing/2014/main" id="{3948D7C9-7B5C-4D21-9385-82562EC0E1C3}"/>
                </a:ext>
              </a:extLst>
            </p:cNvPr>
            <p:cNvSpPr txBox="1"/>
            <p:nvPr/>
          </p:nvSpPr>
          <p:spPr>
            <a:xfrm>
              <a:off x="9226834" y="4373056"/>
              <a:ext cx="71045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plat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" name="文本框 142">
              <a:extLst>
                <a:ext uri="{FF2B5EF4-FFF2-40B4-BE49-F238E27FC236}">
                  <a16:creationId xmlns:a16="http://schemas.microsoft.com/office/drawing/2014/main" id="{4368D815-1A1B-484F-BA64-F414202DA7BA}"/>
                </a:ext>
              </a:extLst>
            </p:cNvPr>
            <p:cNvSpPr txBox="1"/>
            <p:nvPr/>
          </p:nvSpPr>
          <p:spPr>
            <a:xfrm>
              <a:off x="7556621" y="4381862"/>
              <a:ext cx="7745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EP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" name="文本框 144">
              <a:extLst>
                <a:ext uri="{FF2B5EF4-FFF2-40B4-BE49-F238E27FC236}">
                  <a16:creationId xmlns:a16="http://schemas.microsoft.com/office/drawing/2014/main" id="{D578C9E8-B76A-4581-8D99-E812055DD987}"/>
                </a:ext>
              </a:extLst>
            </p:cNvPr>
            <p:cNvSpPr txBox="1"/>
            <p:nvPr/>
          </p:nvSpPr>
          <p:spPr>
            <a:xfrm>
              <a:off x="2571631" y="1231493"/>
              <a:ext cx="27049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essure-controlled mode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" name="文本框 145">
              <a:extLst>
                <a:ext uri="{FF2B5EF4-FFF2-40B4-BE49-F238E27FC236}">
                  <a16:creationId xmlns:a16="http://schemas.microsoft.com/office/drawing/2014/main" id="{153A21AF-B849-4C05-9580-68D91D6E608C}"/>
                </a:ext>
              </a:extLst>
            </p:cNvPr>
            <p:cNvSpPr txBox="1"/>
            <p:nvPr/>
          </p:nvSpPr>
          <p:spPr>
            <a:xfrm>
              <a:off x="7670460" y="1231493"/>
              <a:ext cx="26023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olume-controlled mode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428EA4CD-29DC-4B21-87E6-6AB5159BFD51}"/>
                </a:ext>
              </a:extLst>
            </p:cNvPr>
            <p:cNvSpPr txBox="1"/>
            <p:nvPr/>
          </p:nvSpPr>
          <p:spPr>
            <a:xfrm>
              <a:off x="7528687" y="4936135"/>
              <a:ext cx="25539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EP + (</a:t>
              </a:r>
              <a:r>
                <a:rPr lang="en-US" altLang="zh-CN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peak</a:t>
              </a:r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- </a:t>
              </a:r>
              <a:r>
                <a:rPr lang="en-US" altLang="zh-CN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plat</a:t>
              </a:r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0C014357-2D0B-4B2F-A7D6-5054B903BDBB}"/>
              </a:ext>
            </a:extLst>
          </p:cNvPr>
          <p:cNvCxnSpPr>
            <a:cxnSpLocks/>
          </p:cNvCxnSpPr>
          <p:nvPr/>
        </p:nvCxnSpPr>
        <p:spPr>
          <a:xfrm flipH="1">
            <a:off x="7919509" y="2601533"/>
            <a:ext cx="25668" cy="1828800"/>
          </a:xfrm>
          <a:prstGeom prst="line">
            <a:avLst/>
          </a:prstGeom>
          <a:ln w="381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箭头: 右 1">
            <a:extLst>
              <a:ext uri="{FF2B5EF4-FFF2-40B4-BE49-F238E27FC236}">
                <a16:creationId xmlns:a16="http://schemas.microsoft.com/office/drawing/2014/main" id="{95DCD23D-97EC-40F3-B93D-F59C04112186}"/>
              </a:ext>
            </a:extLst>
          </p:cNvPr>
          <p:cNvSpPr/>
          <p:nvPr/>
        </p:nvSpPr>
        <p:spPr>
          <a:xfrm rot="16200000">
            <a:off x="8446673" y="4651634"/>
            <a:ext cx="430991" cy="109843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0586265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5</Words>
  <Application>Microsoft Office PowerPoint</Application>
  <PresentationFormat>宽屏</PresentationFormat>
  <Paragraphs>18</Paragraphs>
  <Slides>2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池 熠</dc:creator>
  <cp:lastModifiedBy>池 熠</cp:lastModifiedBy>
  <cp:revision>28</cp:revision>
  <dcterms:created xsi:type="dcterms:W3CDTF">2020-08-26T11:21:04Z</dcterms:created>
  <dcterms:modified xsi:type="dcterms:W3CDTF">2020-11-23T14:43:21Z</dcterms:modified>
</cp:coreProperties>
</file>